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6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70"/>
    <p:restoredTop sz="76966"/>
  </p:normalViewPr>
  <p:slideViewPr>
    <p:cSldViewPr snapToGrid="0">
      <p:cViewPr varScale="1">
        <p:scale>
          <a:sx n="57" d="100"/>
          <a:sy n="57" d="100"/>
        </p:scale>
        <p:origin x="13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88A442-FB4E-8346-A88A-3F9F1F328848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EB70E2-FB1F-B549-9C2E-B9C674913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732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685800">
              <a:defRPr/>
            </a:pPr>
            <a:r>
              <a:rPr lang="en-US" sz="1200" b="1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giogenesis and cell stress panels tested at 6 hours post co-culture. (A)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iogenesis markers measured in cell </a:t>
            </a:r>
            <a:r>
              <a:rPr lang="en-US" sz="12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ernatamt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stress markers measured in cell lysates. Panels include hiPSC-derived BMECs only,  hiPSC-derived BMECs with RBCs, and hiPSC-derived BMECs with </a:t>
            </a:r>
            <a:r>
              <a:rPr lang="en-US" sz="12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. Red and blue boxes show differences in angiogenin and platelet factor-4. White box shows differences in phospho-HSP27. Values presented as mean (SEM) from three differentiation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13CCC-C203-394F-8D31-2DD52CC57F8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339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F0B8E87-9F02-5B0E-137D-D48769649A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06924A8F-69DB-14F2-CEFE-B8FF916845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5D736C9-40D3-397F-A8BD-D24C6E09C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0016480-857E-1D49-AD8C-7C9C4A18F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21586F8-1211-30C3-B29F-060C5CF8E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034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AE51B97-5DE2-8AC3-5A25-1157477B6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618E836-CC43-6472-C0A2-8C86D57B00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FEC0BFD-32A7-58D1-1DE9-8E84D33A3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E1BEEB9-EB05-100E-E680-54E2E0EF1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7FF8509-CC91-FF59-1B43-3996E07AA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397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BABE2C38-D660-940F-0EB2-58FD3B2993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B51A440-8C92-280C-9647-CFE86B677A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01D7FF3-2522-6513-965B-5531ED2B4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A012588-DCF0-DFAA-7E14-57046F527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ECFAFF0-E010-4D33-D58A-6D54A0056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250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5A7EFEB-3C79-169A-2780-5E2FC3D1B4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43C27AD-45D8-6B7B-A5C6-85E2086E72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0E49C8E-33AC-8D35-0288-63A1415DE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D8498AC-0BF0-85AF-C3DA-8A27E1621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4731F35-AFE8-BFE2-DA01-03CE833E9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270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ADFC842-F325-9273-3C50-FA3FE012B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A0299AB-2132-6336-FCB7-6E3DBF137B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0372DC2-7A67-62E9-5816-477DA1CF1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DC054B0-18DD-05A6-2271-CD95C126A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4FEB137-CC79-CA79-3B60-4A950BEF8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21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98B7A71-0244-103E-4995-7697BB3A3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BAA9257-A50C-AFEA-C464-F0A676DD86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8318CFD-D31F-35EA-AA79-D6C2F179C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BD78CD0-ADD5-E9C0-7ABD-C52936938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771991B-2364-6392-DE89-B64B1AEBE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7F74447-3FED-E899-6DD1-8B45FD3EC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383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0247A73-F921-9578-DDB8-2DA547A1A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51CB594-290A-068D-3C9F-4488DAEB4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C4C232B-F3D0-3207-0EF8-B9700F0244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FB41DC0-A5F5-77B7-2DA9-C8159B18C4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72B9BA9-99C0-784B-1C38-BB5BFBECCB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0A624DAB-A016-57AC-C3FC-6B75149F9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A164E791-1804-5B3A-4013-1436BB2C4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F1514499-28B0-DB57-19DE-3F97EDBBF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676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6F71AC-CF5A-6CF0-681B-E2016AEB19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6C0DEEC-C34C-F68A-E644-550DB5801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7562881-72AF-7CE8-92E0-DD78CFD31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E990DCC-38A4-0985-D1E2-A9D571B74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398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924E38F-24C9-E7AC-368D-15BAC59D6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BCDA360-63D2-B30D-C4CE-606F19A47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B1ECC24-0791-E332-C516-C84158D31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81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B6916B3-3B15-1424-485E-1F249F637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033B067-117B-C5A1-3A8A-FA9F1DAB9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044071D-5BB2-2D70-B36E-3B96EC265B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ADBA6CE-C35F-71DC-9446-18588496F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D3656E8-2980-02D7-0E3F-292BD2651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7BE30A1-E115-4D10-2AFC-34A33BBD1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805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0225FBC-7D65-CE5F-2F6A-5C103B46B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2887DCF-FE42-E33C-063A-31C4A7800C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DB30151-82F9-80F0-F8B6-2A38491CFE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3CEE11A-9542-278B-6D28-D3EF583FD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7B4D7AC-140B-CEBA-A6E4-70EFB4F71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E160688-7656-4DCB-10C2-CB013ACFB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948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44522345-9098-2B69-F570-8F9357F7B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7D00DA6-51F1-D43C-A934-7B508DE4ED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44089BC-780C-351B-4F1E-675D286C07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6C867A-E370-4245-BED0-24FF14D34AA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7514865-F4C7-34FB-4AD7-E298066143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535D7A8-9EF6-C106-FB3C-995E7F2612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39EBA9-D54C-EB4D-997D-CEEB51E22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891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xmlns="" id="{1499FAC5-3CBA-264D-46ED-5007FD582E8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291574" y="723900"/>
            <a:ext cx="7587094" cy="427990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6503343-0AA0-BCD8-17C8-B9F300A8B923}"/>
              </a:ext>
            </a:extLst>
          </p:cNvPr>
          <p:cNvSpPr txBox="1"/>
          <p:nvPr/>
        </p:nvSpPr>
        <p:spPr>
          <a:xfrm>
            <a:off x="2258786" y="5143500"/>
            <a:ext cx="759278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>
              <a:defRPr/>
            </a:pPr>
            <a:r>
              <a:rPr lang="en-US" sz="1000" b="1" kern="50" spc="-15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giogenesis and cell stress panels tested at 6 hours post co-culture. (A)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iogenesis markers measured in cell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ernatamt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stress markers measured in cell lysates. Panels include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 only, 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 with RBCs, and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 with </a:t>
            </a:r>
            <a:r>
              <a:rPr lang="en-US" sz="1000" i="1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d and blue boxes show differences in angiogenin and platelet factor-4. White box shows differences in phospho-HSP27. Values presented as mean (SEM) from three differentiations.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0148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Props1.xml><?xml version="1.0" encoding="utf-8"?>
<ds:datastoreItem xmlns:ds="http://schemas.openxmlformats.org/officeDocument/2006/customXml" ds:itemID="{7B7D1097-15C9-4710-BF0F-D0EE0FB2067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C5F5D78-A465-4EA0-93F8-F3155BA2C1F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B1D1F22-6F7B-40B2-85B6-E46062A41234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67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2</cp:revision>
  <dcterms:created xsi:type="dcterms:W3CDTF">2024-04-11T17:12:07Z</dcterms:created>
  <dcterms:modified xsi:type="dcterms:W3CDTF">2024-04-20T12:00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</Properties>
</file>